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8CC5EC-03F1-461E-9C0B-0C763CFEFE8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D72F5E-540F-4767-ADB6-24BE00EF772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BA179E-3F22-4F83-9770-8699D21DC74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D57196-C6B9-4F47-948C-EFB7C185279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7ECD68-DA1B-422C-AA37-F1A9B94BE86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B827E0-ADD3-460A-A706-FD13F2B61E4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1B8B83-2ED2-4209-ADF5-2D6E916CEB6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F5B4A4-B41F-4EF9-8F19-DA790AB728E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D7B0A6-3E39-4E2C-A3F1-EB47415353D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BB57A9-5008-4527-9FCC-D757320EECE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33B3B8-C151-45C7-8298-6155EBCAA20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5E37E1-9672-41A4-BA62-94700EF9C23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8AB2D7F-93CF-4CEB-B17A-13ED3C3CBBB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" descr="C:\Users\JANUS\Desktop\Knoepfler Lab\Immunofluorescence Slides\20110616 MEF H3f3b TelC\Merged\MEF KO #39 TelC 5.jpg"/>
          <p:cNvPicPr/>
          <p:nvPr/>
        </p:nvPicPr>
        <p:blipFill>
          <a:blip r:embed="rId1"/>
          <a:srcRect l="41001" t="33335" r="42435" b="44003"/>
          <a:stretch/>
        </p:blipFill>
        <p:spPr>
          <a:xfrm>
            <a:off x="3962520" y="1066680"/>
            <a:ext cx="1407960" cy="172260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5" descr="C:\Users\JANUS\Desktop\Knoepfler Lab\Immunofluorescence Slides\20110621 MEF H3f3b TelC\Merged\MEF H3f3b WT #30 100X TelC 3-1.jpg"/>
          <p:cNvPicPr/>
          <p:nvPr/>
        </p:nvPicPr>
        <p:blipFill>
          <a:blip r:embed="rId2"/>
          <a:srcRect l="41335" t="42076" r="37250" b="40940"/>
          <a:stretch/>
        </p:blipFill>
        <p:spPr>
          <a:xfrm>
            <a:off x="2519280" y="1066680"/>
            <a:ext cx="1366920" cy="1722600"/>
          </a:xfrm>
          <a:prstGeom prst="rect">
            <a:avLst/>
          </a:prstGeom>
          <a:ln w="0">
            <a:noFill/>
          </a:ln>
        </p:spPr>
      </p:pic>
      <p:sp>
        <p:nvSpPr>
          <p:cNvPr id="43" name="TextBox 6"/>
          <p:cNvSpPr/>
          <p:nvPr/>
        </p:nvSpPr>
        <p:spPr>
          <a:xfrm>
            <a:off x="3141720" y="3048120"/>
            <a:ext cx="1134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H3f3b WT 2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7"/>
          <p:cNvSpPr/>
          <p:nvPr/>
        </p:nvSpPr>
        <p:spPr>
          <a:xfrm>
            <a:off x="4116600" y="762120"/>
            <a:ext cx="1102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H3f3b KO 3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5" name="Picture 8" descr="C:\Users\JANUS\Desktop\Knoepfler Lab\Immunofluorescence Slides\20110615 MEF H3f3b TelC\MEF H3f3b KO #31 TelC 1.jpg"/>
          <p:cNvPicPr/>
          <p:nvPr/>
        </p:nvPicPr>
        <p:blipFill>
          <a:blip r:embed="rId3"/>
          <a:srcRect l="30532" t="46743" r="40470" b="26126"/>
          <a:stretch/>
        </p:blipFill>
        <p:spPr>
          <a:xfrm>
            <a:off x="4724280" y="3352680"/>
            <a:ext cx="2179800" cy="182412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9" descr="C:\Users\JANUS\Desktop\Knoepfler Lab\Immunofluorescence Slides\20110615 MEF H3f3b TelC\MEF H3f3b WT #27 TelC 1.jpg"/>
          <p:cNvPicPr/>
          <p:nvPr/>
        </p:nvPicPr>
        <p:blipFill>
          <a:blip r:embed="rId4"/>
          <a:srcRect l="56658" t="48334" r="19970" b="29669"/>
          <a:stretch/>
        </p:blipFill>
        <p:spPr>
          <a:xfrm>
            <a:off x="2514600" y="3352680"/>
            <a:ext cx="2168640" cy="1825920"/>
          </a:xfrm>
          <a:prstGeom prst="rect">
            <a:avLst/>
          </a:prstGeom>
          <a:ln w="0">
            <a:noFill/>
          </a:ln>
        </p:spPr>
      </p:pic>
      <p:sp>
        <p:nvSpPr>
          <p:cNvPr id="47" name="TextBox 12"/>
          <p:cNvSpPr/>
          <p:nvPr/>
        </p:nvSpPr>
        <p:spPr>
          <a:xfrm>
            <a:off x="2152800" y="1143000"/>
            <a:ext cx="307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(i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Box 13"/>
          <p:cNvSpPr/>
          <p:nvPr/>
        </p:nvSpPr>
        <p:spPr>
          <a:xfrm>
            <a:off x="2135520" y="3352680"/>
            <a:ext cx="342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(ii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13"/>
          <p:cNvSpPr/>
          <p:nvPr/>
        </p:nvSpPr>
        <p:spPr>
          <a:xfrm>
            <a:off x="0" y="6172200"/>
            <a:ext cx="91440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l Figure S4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Telomere FISH (green) on WT and H3f3b KO cells either arrested in (i) metaphase  or (ii) unsynchronized in interphase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14"/>
          <p:cNvSpPr/>
          <p:nvPr/>
        </p:nvSpPr>
        <p:spPr>
          <a:xfrm>
            <a:off x="5576760" y="0"/>
            <a:ext cx="3564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ush, et al., Supplemental Figure S4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6"/>
          <p:cNvSpPr/>
          <p:nvPr/>
        </p:nvSpPr>
        <p:spPr>
          <a:xfrm>
            <a:off x="2745000" y="762120"/>
            <a:ext cx="1134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H3f3b WT 2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7"/>
          <p:cNvSpPr/>
          <p:nvPr/>
        </p:nvSpPr>
        <p:spPr>
          <a:xfrm>
            <a:off x="5259600" y="3048120"/>
            <a:ext cx="1102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H3f3b KO 3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3-11T23:13:18Z</dcterms:created>
  <dc:creator>Research User</dc:creator>
  <dc:description/>
  <dc:language>en-US</dc:language>
  <cp:lastModifiedBy>Paul Knoepfler</cp:lastModifiedBy>
  <dcterms:modified xsi:type="dcterms:W3CDTF">2013-03-18T22:02:07Z</dcterms:modified>
  <cp:revision>7</cp:revision>
  <dc:subject/>
  <dc:title>PowerPoint Presentation</dc:title>
</cp:coreProperties>
</file>